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1020" y="-49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5FBAC-1AA4-49ED-BBD2-9085BBAE6FD9}" type="datetimeFigureOut">
              <a:rPr lang="en-US" smtClean="0"/>
              <a:t>4/23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943B0-CB23-445A-8165-0098FD50C5E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358901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5FBAC-1AA4-49ED-BBD2-9085BBAE6FD9}" type="datetimeFigureOut">
              <a:rPr lang="en-US" smtClean="0"/>
              <a:t>4/23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943B0-CB23-445A-8165-0098FD50C5E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998475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5FBAC-1AA4-49ED-BBD2-9085BBAE6FD9}" type="datetimeFigureOut">
              <a:rPr lang="en-US" smtClean="0"/>
              <a:t>4/23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943B0-CB23-445A-8165-0098FD50C5E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404152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5FBAC-1AA4-49ED-BBD2-9085BBAE6FD9}" type="datetimeFigureOut">
              <a:rPr lang="en-US" smtClean="0"/>
              <a:t>4/23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943B0-CB23-445A-8165-0098FD50C5E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836139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5FBAC-1AA4-49ED-BBD2-9085BBAE6FD9}" type="datetimeFigureOut">
              <a:rPr lang="en-US" smtClean="0"/>
              <a:t>4/23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943B0-CB23-445A-8165-0098FD50C5E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900947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5FBAC-1AA4-49ED-BBD2-9085BBAE6FD9}" type="datetimeFigureOut">
              <a:rPr lang="en-US" smtClean="0"/>
              <a:t>4/23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943B0-CB23-445A-8165-0098FD50C5E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654815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5FBAC-1AA4-49ED-BBD2-9085BBAE6FD9}" type="datetimeFigureOut">
              <a:rPr lang="en-US" smtClean="0"/>
              <a:t>4/23/2024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943B0-CB23-445A-8165-0098FD50C5E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602857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5FBAC-1AA4-49ED-BBD2-9085BBAE6FD9}" type="datetimeFigureOut">
              <a:rPr lang="en-US" smtClean="0"/>
              <a:t>4/23/2024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943B0-CB23-445A-8165-0098FD50C5E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225541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5FBAC-1AA4-49ED-BBD2-9085BBAE6FD9}" type="datetimeFigureOut">
              <a:rPr lang="en-US" smtClean="0"/>
              <a:t>4/23/2024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943B0-CB23-445A-8165-0098FD50C5E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473062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5FBAC-1AA4-49ED-BBD2-9085BBAE6FD9}" type="datetimeFigureOut">
              <a:rPr lang="en-US" smtClean="0"/>
              <a:t>4/23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943B0-CB23-445A-8165-0098FD50C5E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857529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5FBAC-1AA4-49ED-BBD2-9085BBAE6FD9}" type="datetimeFigureOut">
              <a:rPr lang="en-US" smtClean="0"/>
              <a:t>4/23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943B0-CB23-445A-8165-0098FD50C5E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428135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15FBAC-1AA4-49ED-BBD2-9085BBAE6FD9}" type="datetimeFigureOut">
              <a:rPr lang="en-US" smtClean="0"/>
              <a:t>4/23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4943B0-CB23-445A-8165-0098FD50C5E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626098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A49B7DCE-B7FC-41B1-A247-8730E5FEE04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706342" y="286870"/>
            <a:ext cx="3445315" cy="10514387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6A4D62B4-2042-4DDD-9022-445AD6288793}"/>
              </a:ext>
            </a:extLst>
          </p:cNvPr>
          <p:cNvSpPr txBox="1"/>
          <p:nvPr/>
        </p:nvSpPr>
        <p:spPr>
          <a:xfrm>
            <a:off x="125506" y="10845384"/>
            <a:ext cx="6535644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. Additional photomicrographs from Case 3, AT8 immunohistochemistry. (A), (B), and (C) High magnification (scale bars = 200 µm) images of isolated, mid-cortical neuronal tau accumulation in frontal, temporal, and parietal cortical samples, respectively. </a:t>
            </a:r>
          </a:p>
        </p:txBody>
      </p:sp>
    </p:spTree>
    <p:extLst>
      <p:ext uri="{BB962C8B-B14F-4D97-AF65-F5344CB8AC3E}">
        <p14:creationId xmlns:p14="http://schemas.microsoft.com/office/powerpoint/2010/main" val="35222464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</TotalTime>
  <Words>52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ymond Sobel</dc:creator>
  <cp:lastModifiedBy>Raymond Sobel</cp:lastModifiedBy>
  <cp:revision>4</cp:revision>
  <dcterms:created xsi:type="dcterms:W3CDTF">2024-04-23T20:59:38Z</dcterms:created>
  <dcterms:modified xsi:type="dcterms:W3CDTF">2024-04-23T21:07:52Z</dcterms:modified>
</cp:coreProperties>
</file>